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40EB1-B72A-4DA1-988E-9BA31B8E1D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53FB5-1A0E-4A7A-A31A-EF592DC088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C848E-2C61-4E95-AF5B-0841E3107A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0BE6F-F301-46C7-A6DD-DAE9772DC8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90E1A-3043-4016-8BD5-978CC07EAD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34116-D076-462B-A7A0-B120DA9E55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BBCCA-8C51-4F3F-B647-5A2DC0F305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8CD34-6DA5-46CD-8EDA-2C9032C274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B9BED-A125-41F9-A76D-3D0A0092CF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ACD5A-825F-4447-98D9-AC1FDB49AF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BDB61-A018-48F4-BB6F-0451C0769B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CADAD-A287-4289-BB80-CB4EE31DD4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57FEA2-49C5-4499-9FD6-3C0B00BF0E2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333000" y="1856880"/>
            <a:ext cx="6380280" cy="1871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n-Random Distribution of EMS-Induced Mutations Reveals Preference for Open Chromatin and Expressed Genes in Ric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"/>
          <p:cNvGraphicFramePr/>
          <p:nvPr/>
        </p:nvGraphicFramePr>
        <p:xfrm>
          <a:off x="536400" y="1136520"/>
          <a:ext cx="5845320" cy="1378080"/>
        </p:xfrm>
        <a:graphic>
          <a:graphicData uri="http://schemas.openxmlformats.org/drawingml/2006/table">
            <a:tbl>
              <a:tblPr/>
              <a:tblGrid>
                <a:gridCol w="1036800"/>
                <a:gridCol w="1177920"/>
                <a:gridCol w="1177920"/>
                <a:gridCol w="797040"/>
                <a:gridCol w="712800"/>
                <a:gridCol w="942840"/>
              </a:tblGrid>
              <a:tr h="54936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genized popul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M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ncentr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s of M1 seed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rmina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rvival rates of M1 plants (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rtilized M1 lines obtain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centages of M2 lines with albino phenotyp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612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MS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 m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,8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,5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7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648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MS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5 m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,5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,2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6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612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MS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0 m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,8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,0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4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3" name="Rectangle 1"/>
          <p:cNvSpPr/>
          <p:nvPr/>
        </p:nvSpPr>
        <p:spPr>
          <a:xfrm>
            <a:off x="479520" y="776880"/>
            <a:ext cx="475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mmary of EMS-induced mutagenesis performed in this stud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1413000" y="1600200"/>
          <a:ext cx="3816360" cy="3857760"/>
        </p:xfrm>
        <a:graphic>
          <a:graphicData uri="http://schemas.openxmlformats.org/drawingml/2006/table">
            <a:tbl>
              <a:tblPr/>
              <a:tblGrid>
                <a:gridCol w="930240"/>
                <a:gridCol w="1571400"/>
                <a:gridCol w="1314720"/>
              </a:tblGrid>
              <a:tr h="192240"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ass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enotype descrip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s of lin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 rowSpan="3"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黑体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黑体"/>
                        </a:rPr>
                        <a:t>Spikele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ect panic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4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normal infloresc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4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und spikele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 rowSpan="2"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ower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ter flower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arly flower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 rowSpan="5"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av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aves with strip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39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aves with lesion mimic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4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hite marg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4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af tip necro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4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rrow lea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 rowSpan="3"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/till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ther Tiller rela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4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warf and semi-dwar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 till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560">
                <a:tc rowSpan="2"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in culm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4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agile ste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 rowSpan="2"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ed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und seed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4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ed shattering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0" bIns="0" anchor="ctr">
                      <a:noAutofit/>
                    </a:bodyPr>
                    <a:p>
                      <a:pPr algn="ctr"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5" name="TextBox 2"/>
          <p:cNvSpPr/>
          <p:nvPr/>
        </p:nvSpPr>
        <p:spPr>
          <a:xfrm>
            <a:off x="1268280" y="1281240"/>
            <a:ext cx="493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mmary of the observed phenotypes of some M2 plan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"/>
          <p:cNvGraphicFramePr/>
          <p:nvPr/>
        </p:nvGraphicFramePr>
        <p:xfrm>
          <a:off x="436680" y="2432160"/>
          <a:ext cx="6003720" cy="1376280"/>
        </p:xfrm>
        <a:graphic>
          <a:graphicData uri="http://schemas.openxmlformats.org/drawingml/2006/table">
            <a:tbl>
              <a:tblPr/>
              <a:tblGrid>
                <a:gridCol w="971280"/>
                <a:gridCol w="868680"/>
                <a:gridCol w="1512720"/>
                <a:gridCol w="1008000"/>
                <a:gridCol w="1008000"/>
                <a:gridCol w="635040"/>
              </a:tblGrid>
              <a:tr h="4633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tagenized popula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2 lines sequenc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clean bases obtained (Tb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 bases (Gb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 sequencing depths per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30 (%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049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S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2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.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03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S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4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049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,6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7" name="TextBox 4"/>
          <p:cNvSpPr/>
          <p:nvPr/>
        </p:nvSpPr>
        <p:spPr>
          <a:xfrm>
            <a:off x="360360" y="2160720"/>
            <a:ext cx="609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3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mmary of genomic sequencing of mutagenized M2 rice plant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404640" y="1568520"/>
          <a:ext cx="5904000" cy="1039680"/>
        </p:xfrm>
        <a:graphic>
          <a:graphicData uri="http://schemas.openxmlformats.org/drawingml/2006/table">
            <a:tbl>
              <a:tblPr/>
              <a:tblGrid>
                <a:gridCol w="1067040"/>
                <a:gridCol w="853920"/>
                <a:gridCol w="817560"/>
                <a:gridCol w="676440"/>
                <a:gridCol w="1138320"/>
                <a:gridCol w="1350720"/>
              </a:tblGrid>
              <a:tr h="4183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tagenized popul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ne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P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dentifi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P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 li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stributions of SNP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Kb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P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 Kb in whole popu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077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S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2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304,1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496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0664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S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4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,103,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70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0700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,6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407,2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6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9" name="矩形 4"/>
          <p:cNvSpPr/>
          <p:nvPr/>
        </p:nvSpPr>
        <p:spPr>
          <a:xfrm>
            <a:off x="333360" y="2649600"/>
            <a:ext cx="6191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The reference ZH11 genome size of ~370 Mb was used to calculate sequencing dept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333360" y="1292400"/>
            <a:ext cx="59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4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SNP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 and mutation densities in each subpopulation of Rice4619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1"/>
          <p:cNvSpPr/>
          <p:nvPr/>
        </p:nvSpPr>
        <p:spPr>
          <a:xfrm>
            <a:off x="260280" y="284040"/>
            <a:ext cx="674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5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NP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selected for re-sequencing analyses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"/>
          <p:cNvSpPr/>
          <p:nvPr/>
        </p:nvSpPr>
        <p:spPr>
          <a:xfrm>
            <a:off x="189000" y="8913960"/>
            <a:ext cx="651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a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omo, homozygous; Hetero, heterozygou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333360" y="631800"/>
          <a:ext cx="6264360" cy="8196120"/>
        </p:xfrm>
        <a:graphic>
          <a:graphicData uri="http://schemas.openxmlformats.org/drawingml/2006/table">
            <a:tbl>
              <a:tblPr/>
              <a:tblGrid>
                <a:gridCol w="406440"/>
                <a:gridCol w="406440"/>
                <a:gridCol w="406440"/>
                <a:gridCol w="738000"/>
                <a:gridCol w="692280"/>
                <a:gridCol w="895320"/>
                <a:gridCol w="631800"/>
                <a:gridCol w="1166760"/>
                <a:gridCol w="920880"/>
              </a:tblGrid>
              <a:tr h="2491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nes 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. 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M Positions in Chromoso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itu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ino acid chang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zy-gosities</a:t>
                      </a:r>
                      <a:r>
                        <a:rPr b="1" lang="en-US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ID (ZH11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ID (MSU 7.0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5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8219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95V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37637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56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5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8219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69Th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37637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56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493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111Ph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2206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153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5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489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u233Ph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2206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153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1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488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283As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2206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153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3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488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274As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2206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153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2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490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214S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2206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153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4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492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126Th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2206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153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7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740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&gt;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n114Ar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737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5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6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5876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563S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4747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510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5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742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161Th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737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5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32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5080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al376Il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1207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556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32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739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62Le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737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5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8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110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69As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1230738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12g08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2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1805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n211Ly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717684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7g424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1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100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317Ar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1230738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12g08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1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482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u37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1999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093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0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482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r67Il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1999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093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8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464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8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5980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23S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2820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326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6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645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85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4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633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85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4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6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665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390Th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85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4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89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670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g483H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85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4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6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3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675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552S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85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4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30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3785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82S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510449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5g343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9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3776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u259Ph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510449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5g343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2822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/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2864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UT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406832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4g382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5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2864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7S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406832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4g382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5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3299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g534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4070089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4g329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2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352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n170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922107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9g086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3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3703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n258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3670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541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9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015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p36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1840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046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7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9944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p970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1022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481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2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1619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ys422Me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3409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474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8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1610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r264Il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3409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474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9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6200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p111As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15474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690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3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8418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324Ph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3052618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3g434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8421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228Ph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3052618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3g434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8422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169V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3052618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3g434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0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8424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u129H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3052618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3g434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8424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g126Gl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3052618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3g434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5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082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ys700Ly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659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39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084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760S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659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39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5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086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n808As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659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39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089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887V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659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39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2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090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al910Il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6116659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6g039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9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2289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153Le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0963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455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2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8272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227V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1395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627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28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8275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326As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1395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627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3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8272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228V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1395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627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12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8271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a212Th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101395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1g627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2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2358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&gt;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485As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35437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508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4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30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2362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&gt;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r651Il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ZH11G02035437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_Os02g508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"/>
          <p:cNvGraphicFramePr/>
          <p:nvPr/>
        </p:nvGraphicFramePr>
        <p:xfrm>
          <a:off x="620640" y="776160"/>
          <a:ext cx="5832720" cy="1297080"/>
        </p:xfrm>
        <a:graphic>
          <a:graphicData uri="http://schemas.openxmlformats.org/drawingml/2006/table">
            <a:tbl>
              <a:tblPr/>
              <a:tblGrid>
                <a:gridCol w="690480"/>
                <a:gridCol w="1148040"/>
                <a:gridCol w="838080"/>
                <a:gridCol w="798480"/>
                <a:gridCol w="876240"/>
                <a:gridCol w="852480"/>
                <a:gridCol w="628920"/>
              </a:tblGrid>
              <a:tr h="351000"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pul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-synonymou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ynonymou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op cod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49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 G/C&gt;A/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C&gt;A/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 G/C&gt;A/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C&gt;A/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 G/C&gt;A/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C&gt;A/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8440"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S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.9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4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8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0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5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98440"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S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9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8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0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8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5" name="矩形 4"/>
          <p:cNvSpPr/>
          <p:nvPr/>
        </p:nvSpPr>
        <p:spPr>
          <a:xfrm>
            <a:off x="333360" y="530280"/>
            <a:ext cx="669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6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ison of non-G/C-to-A/T and G/C-to-A/T conversions in non-synonymous and synonymous mutation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0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23T14:50:32Z</dcterms:created>
  <dc:creator>Shengyang Wu</dc:creator>
  <dc:description/>
  <dc:language>en-US</dc:language>
  <cp:lastModifiedBy>webuser</cp:lastModifiedBy>
  <cp:lastPrinted>2022-03-03T00:49:22Z</cp:lastPrinted>
  <dcterms:modified xsi:type="dcterms:W3CDTF">2025-06-28T07:59:29Z</dcterms:modified>
  <cp:revision>612</cp:revision>
  <dc:subject/>
  <dc:title>PowerPoint 演示文稿</dc:title>
</cp:coreProperties>
</file>